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image" Target="../media/image6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image" Target="../media/image9.wmf"/><Relationship Id="rId1" Type="http://schemas.openxmlformats.org/officeDocument/2006/relationships/image" Target="../media/image8.wmf"/><Relationship Id="rId6" Type="http://schemas.openxmlformats.org/officeDocument/2006/relationships/image" Target="../media/image13.wmf"/><Relationship Id="rId5" Type="http://schemas.openxmlformats.org/officeDocument/2006/relationships/image" Target="../media/image12.wmf"/><Relationship Id="rId4" Type="http://schemas.openxmlformats.org/officeDocument/2006/relationships/image" Target="../media/image11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6.wmf"/><Relationship Id="rId2" Type="http://schemas.openxmlformats.org/officeDocument/2006/relationships/image" Target="../media/image15.wmf"/><Relationship Id="rId1" Type="http://schemas.openxmlformats.org/officeDocument/2006/relationships/image" Target="../media/image14.wmf"/><Relationship Id="rId4" Type="http://schemas.openxmlformats.org/officeDocument/2006/relationships/image" Target="../media/image1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96A52E-E1F0-4E86-B10B-F3827814B1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82614F-1CB1-4651-9559-0D76254255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913A4-7546-4482-8B40-303E81721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8AA5E7-B98F-4C00-B2FC-9D7F29F15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DF073-4651-4B0D-9875-EBD5062E8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654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1B7D9-4908-4868-AD4C-3EDA23881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B65964-5EA1-4ACE-B2E6-1565A8A3FB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6FF0C3-6E02-4230-B7AD-674F7FBAC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4D98A-2376-44F0-A42C-89C288408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05A969-5F62-4923-8555-888F15C94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494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788422-D1CD-43CE-BA8D-52F154BAA0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AC94B7-A8E6-49FF-93C6-32D613D94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38AA2-F6E7-4399-8ED6-06EBB2537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1F463-29A3-41C0-82EA-25A4C0DCA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4B2D0C-14E8-4A8F-864B-C2A32AD8C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66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8BCDD-10BE-47EB-9F16-74E0217D7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B6FB92-973A-426C-946E-D1F2EB51E2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1291E5-A89F-4BA2-ADB9-BC740E640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1BF151-B531-48DB-858C-3B4D73BFF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694837-50BD-4870-8A78-F88D4000F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91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3D1AC-01D8-4301-98F6-AB9CD58803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123AE2-6202-40E0-920A-D665C1D3A9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DA4FB2-FE2C-4EFB-BE3B-EFC157F97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540900-437A-4B33-B92C-3214D3D06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6AA44A-33BA-49A6-BCC3-90FE6FB93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710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B2B9A-CA65-46CE-82BA-0400C355B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ED44D7-38F1-44EC-BB32-C400E99D5D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EBDFB5-16E6-4093-BE35-390D3FA973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75D88A-6540-47BF-B8D1-59362F8E5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24197-FA8C-4BC9-B1AE-1DCD1241B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6DD571-D791-4F43-94A3-404820FFA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505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FC60F-F77E-444C-AF66-283EE8594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A94089-809C-4324-A450-23583EEC5D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CD5661-D6ED-485A-8888-66CECBD948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F9A5F4-480D-4F8A-90D6-A2593D8270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2E3A87-0A68-4913-8E5E-20946737D6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713F1B-2E8D-46D5-984A-EEDA543C3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0E92CF-AA05-4FBE-BF8E-A11981B01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64A21D-8429-4B61-8011-ADBF0C7F7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009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2F5500-A507-4C21-88DC-78F34EE95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88612D-B7C5-4809-9223-3543C8A12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9157D9-C5A6-442D-A947-CB5503C4A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327DEC-9693-43A0-82E9-5804F93CA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300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BF784E-BEA0-4548-9DE7-AFBA96006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F64EA1-72AA-4515-970B-26BBACA92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753E2E-A838-4C89-BE17-B3D3DB188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601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74150A-42C3-4A62-9056-8347A7E6A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9BB84E-3E9C-4503-92B0-9341B5EB34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0118C-1B32-4E6A-80A6-CE8C816F16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88143-3B1A-4365-B298-614830338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807B3B-DD1F-487E-846E-3E67A7F22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922983-24CA-4FC7-A7F5-3A2570793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49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41F37-614F-49FF-A767-9F79362ED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720175-7189-4211-A3B3-E347EBA3C4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C7E1D7-146A-4FCC-8DDF-7D750F929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4494BD-A075-4E1D-90AD-64C943E2B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285CCE-1C18-4784-BBDA-2B936AB97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39E298-B57A-49CB-96F4-3F3A6DAD8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777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F03A2B-5087-47E9-8DE7-ED5E4808E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A3F0CE-4A57-46C2-A965-5EE91E9E31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61A661-138A-4B29-BE3B-734CD35BD1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FF4C5-289D-4084-850B-1945E74AD6B9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98D80-5710-453C-8AB0-C1EB223F67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15E18-0ABB-418C-90D5-C5AC096244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04221-C7CD-468F-B0CE-213439E18F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430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w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1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w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1.wmf"/><Relationship Id="rId4" Type="http://schemas.openxmlformats.org/officeDocument/2006/relationships/image" Target="../media/image8.w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13.w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w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wmf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17.wmf"/><Relationship Id="rId4" Type="http://schemas.openxmlformats.org/officeDocument/2006/relationships/image" Target="../media/image14.wmf"/><Relationship Id="rId9" Type="http://schemas.openxmlformats.org/officeDocument/2006/relationships/oleObject" Target="../embeddings/oleObject1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0319A87-0C7D-46F3-B56A-7658C9CB168A}"/>
              </a:ext>
            </a:extLst>
          </p:cNvPr>
          <p:cNvSpPr txBox="1"/>
          <p:nvPr/>
        </p:nvSpPr>
        <p:spPr>
          <a:xfrm>
            <a:off x="5671682" y="1132685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B57494-204C-460E-AF6C-9780AFCA5ED9}"/>
              </a:ext>
            </a:extLst>
          </p:cNvPr>
          <p:cNvSpPr txBox="1"/>
          <p:nvPr/>
        </p:nvSpPr>
        <p:spPr>
          <a:xfrm>
            <a:off x="4042711" y="406680"/>
            <a:ext cx="4106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mmary tumors-Western blot-Film scan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162E6B2-0F0B-4E66-9E96-AD4B9DF454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843" y="2352412"/>
            <a:ext cx="10681980" cy="388435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A0E30B3-CCAE-4BEF-A417-9060ACC0D5EE}"/>
              </a:ext>
            </a:extLst>
          </p:cNvPr>
          <p:cNvSpPr txBox="1"/>
          <p:nvPr/>
        </p:nvSpPr>
        <p:spPr>
          <a:xfrm>
            <a:off x="2726422" y="1952302"/>
            <a:ext cx="86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            1              2             3         4            5          6           7            8           9</a:t>
            </a:r>
          </a:p>
        </p:txBody>
      </p:sp>
    </p:spTree>
    <p:extLst>
      <p:ext uri="{BB962C8B-B14F-4D97-AF65-F5344CB8AC3E}">
        <p14:creationId xmlns:p14="http://schemas.microsoft.com/office/powerpoint/2010/main" val="27765493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17B6451-1740-4564-91A0-9B7B8D5B26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796" y="2465323"/>
            <a:ext cx="10689771" cy="384810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4C6EC20-6D3E-414A-AB71-1C5D081A525F}"/>
              </a:ext>
            </a:extLst>
          </p:cNvPr>
          <p:cNvSpPr txBox="1"/>
          <p:nvPr/>
        </p:nvSpPr>
        <p:spPr>
          <a:xfrm>
            <a:off x="5178490" y="867747"/>
            <a:ext cx="1502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AKT</a:t>
            </a:r>
            <a:r>
              <a:rPr lang="en-US" dirty="0"/>
              <a:t> (ser473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D79321-7351-4F7D-A033-D9BB6E65BD11}"/>
              </a:ext>
            </a:extLst>
          </p:cNvPr>
          <p:cNvSpPr txBox="1"/>
          <p:nvPr/>
        </p:nvSpPr>
        <p:spPr>
          <a:xfrm>
            <a:off x="4042711" y="406680"/>
            <a:ext cx="4106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mmary tumors-Western blot-Film sca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17DBA23-319E-4A2A-905A-FFA1FCE987FA}"/>
              </a:ext>
            </a:extLst>
          </p:cNvPr>
          <p:cNvSpPr txBox="1"/>
          <p:nvPr/>
        </p:nvSpPr>
        <p:spPr>
          <a:xfrm>
            <a:off x="2122415" y="2065213"/>
            <a:ext cx="86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            1              2             3         4            5          6           7            8           9</a:t>
            </a:r>
          </a:p>
        </p:txBody>
      </p:sp>
    </p:spTree>
    <p:extLst>
      <p:ext uri="{BB962C8B-B14F-4D97-AF65-F5344CB8AC3E}">
        <p14:creationId xmlns:p14="http://schemas.microsoft.com/office/powerpoint/2010/main" val="675962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87D05F6F-2BD7-4F48-A0B8-9C240596A8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6718" y="2509020"/>
            <a:ext cx="10686165" cy="269225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6718CBC-C8F7-4B85-B9D1-A8AEEC538CFF}"/>
              </a:ext>
            </a:extLst>
          </p:cNvPr>
          <p:cNvSpPr txBox="1"/>
          <p:nvPr/>
        </p:nvSpPr>
        <p:spPr>
          <a:xfrm>
            <a:off x="5533053" y="1129004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166A23-AABD-4DD4-A57D-E09470AB6630}"/>
              </a:ext>
            </a:extLst>
          </p:cNvPr>
          <p:cNvSpPr txBox="1"/>
          <p:nvPr/>
        </p:nvSpPr>
        <p:spPr>
          <a:xfrm>
            <a:off x="4042711" y="406680"/>
            <a:ext cx="4106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mmary tumors-Western blot-Film sca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B4057D-4FAA-4AE4-B20D-5410F58EE10E}"/>
              </a:ext>
            </a:extLst>
          </p:cNvPr>
          <p:cNvSpPr txBox="1"/>
          <p:nvPr/>
        </p:nvSpPr>
        <p:spPr>
          <a:xfrm>
            <a:off x="2111226" y="2115524"/>
            <a:ext cx="86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            1              2             3         4            5          6           7            8           9</a:t>
            </a:r>
          </a:p>
        </p:txBody>
      </p:sp>
    </p:spTree>
    <p:extLst>
      <p:ext uri="{BB962C8B-B14F-4D97-AF65-F5344CB8AC3E}">
        <p14:creationId xmlns:p14="http://schemas.microsoft.com/office/powerpoint/2010/main" val="2710265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2431A82-13E2-4C87-809F-081BCD7E52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67" y="2260628"/>
            <a:ext cx="10786959" cy="25295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028125-6BE3-480F-AE22-30F18F7D21BB}"/>
              </a:ext>
            </a:extLst>
          </p:cNvPr>
          <p:cNvSpPr txBox="1"/>
          <p:nvPr/>
        </p:nvSpPr>
        <p:spPr>
          <a:xfrm>
            <a:off x="5832947" y="1061012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6B1B868-200B-4F35-84CD-A01165752D91}"/>
              </a:ext>
            </a:extLst>
          </p:cNvPr>
          <p:cNvSpPr txBox="1"/>
          <p:nvPr/>
        </p:nvSpPr>
        <p:spPr>
          <a:xfrm>
            <a:off x="4042711" y="406680"/>
            <a:ext cx="4106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mmary tumors-Western blot-Film sca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947BEE-535B-4B27-904D-1BC3423662B6}"/>
              </a:ext>
            </a:extLst>
          </p:cNvPr>
          <p:cNvSpPr txBox="1"/>
          <p:nvPr/>
        </p:nvSpPr>
        <p:spPr>
          <a:xfrm>
            <a:off x="2256639" y="1860518"/>
            <a:ext cx="86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            1              2             3         4            5          6           7            8           9</a:t>
            </a:r>
          </a:p>
        </p:txBody>
      </p:sp>
    </p:spTree>
    <p:extLst>
      <p:ext uri="{BB962C8B-B14F-4D97-AF65-F5344CB8AC3E}">
        <p14:creationId xmlns:p14="http://schemas.microsoft.com/office/powerpoint/2010/main" val="35356461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A picture containing water&#10;&#10;Description automatically generated">
            <a:extLst>
              <a:ext uri="{FF2B5EF4-FFF2-40B4-BE49-F238E27FC236}">
                <a16:creationId xmlns:a16="http://schemas.microsoft.com/office/drawing/2014/main" id="{210FFDEA-22D8-455D-BB8E-3EEB65B9BA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698" y="2465323"/>
            <a:ext cx="10556604" cy="3423209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B44B7D6-D1B2-4078-A6CF-AFB47151E767}"/>
              </a:ext>
            </a:extLst>
          </p:cNvPr>
          <p:cNvSpPr txBox="1"/>
          <p:nvPr/>
        </p:nvSpPr>
        <p:spPr>
          <a:xfrm>
            <a:off x="5527988" y="1462755"/>
            <a:ext cx="113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ta-act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76F136D-F7D5-44ED-B595-6A88564368EF}"/>
              </a:ext>
            </a:extLst>
          </p:cNvPr>
          <p:cNvSpPr txBox="1"/>
          <p:nvPr/>
        </p:nvSpPr>
        <p:spPr>
          <a:xfrm>
            <a:off x="4042711" y="406680"/>
            <a:ext cx="4106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mmary tumors-Western blot-Film sca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B7C89F7-B6CF-49D9-91A6-F5AF955FE20B}"/>
              </a:ext>
            </a:extLst>
          </p:cNvPr>
          <p:cNvSpPr txBox="1"/>
          <p:nvPr/>
        </p:nvSpPr>
        <p:spPr>
          <a:xfrm>
            <a:off x="2122415" y="2065213"/>
            <a:ext cx="8674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            1              2             3         4            5          6           7            8           9</a:t>
            </a:r>
          </a:p>
        </p:txBody>
      </p:sp>
    </p:spTree>
    <p:extLst>
      <p:ext uri="{BB962C8B-B14F-4D97-AF65-F5344CB8AC3E}">
        <p14:creationId xmlns:p14="http://schemas.microsoft.com/office/powerpoint/2010/main" val="8717068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F0E2872-ECB1-4CC0-9EFB-02EBAF439C70}"/>
              </a:ext>
            </a:extLst>
          </p:cNvPr>
          <p:cNvSpPr txBox="1"/>
          <p:nvPr/>
        </p:nvSpPr>
        <p:spPr>
          <a:xfrm>
            <a:off x="2705282" y="211566"/>
            <a:ext cx="6957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 vitro treated mammary cancer cells-Western blot-G Box imager scans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5128100-266B-4350-B497-239C41B966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5825060"/>
              </p:ext>
            </p:extLst>
          </p:nvPr>
        </p:nvGraphicFramePr>
        <p:xfrm>
          <a:off x="6332456" y="1246807"/>
          <a:ext cx="1149350" cy="554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r:id="rId3" imgW="1713960" imgH="8285400" progId="">
                  <p:embed/>
                </p:oleObj>
              </mc:Choice>
              <mc:Fallback>
                <p:oleObj r:id="rId3" imgW="171396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32456" y="1246807"/>
                        <a:ext cx="1149350" cy="554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8D27EA3-2C22-4107-AF58-19EA055324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4983410"/>
              </p:ext>
            </p:extLst>
          </p:nvPr>
        </p:nvGraphicFramePr>
        <p:xfrm>
          <a:off x="3066596" y="1111250"/>
          <a:ext cx="1225550" cy="554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r:id="rId5" imgW="1828440" imgH="8285400" progId="">
                  <p:embed/>
                </p:oleObj>
              </mc:Choice>
              <mc:Fallback>
                <p:oleObj r:id="rId5" imgW="182844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66596" y="1111250"/>
                        <a:ext cx="1225550" cy="554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B115BEB-DF2D-415D-9173-39FC97B4BFAF}"/>
              </a:ext>
            </a:extLst>
          </p:cNvPr>
          <p:cNvSpPr txBox="1"/>
          <p:nvPr/>
        </p:nvSpPr>
        <p:spPr>
          <a:xfrm>
            <a:off x="1622910" y="741918"/>
            <a:ext cx="3352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hite light picture of membran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8E05AD-829D-416F-BC1E-E9142FF2801B}"/>
              </a:ext>
            </a:extLst>
          </p:cNvPr>
          <p:cNvSpPr txBox="1"/>
          <p:nvPr/>
        </p:nvSpPr>
        <p:spPr>
          <a:xfrm>
            <a:off x="5608639" y="793005"/>
            <a:ext cx="29087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0" i="0" dirty="0">
                <a:effectLst/>
              </a:rPr>
              <a:t>chemiluminescent detection</a:t>
            </a:r>
            <a:r>
              <a:rPr lang="en-US" dirty="0"/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200100-5DA9-43F6-82C6-025BA9B91330}"/>
              </a:ext>
            </a:extLst>
          </p:cNvPr>
          <p:cNvSpPr txBox="1"/>
          <p:nvPr/>
        </p:nvSpPr>
        <p:spPr>
          <a:xfrm>
            <a:off x="5760010" y="2313597"/>
            <a:ext cx="671979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 err="1"/>
              <a:t>pAKT</a:t>
            </a:r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S6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pS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8BFCD6-E455-4525-8C8A-1596AF064E45}"/>
              </a:ext>
            </a:extLst>
          </p:cNvPr>
          <p:cNvSpPr txBox="1"/>
          <p:nvPr/>
        </p:nvSpPr>
        <p:spPr>
          <a:xfrm>
            <a:off x="6500512" y="136079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0F52C4-DFF9-467F-8B2C-C320286E658D}"/>
              </a:ext>
            </a:extLst>
          </p:cNvPr>
          <p:cNvSpPr txBox="1"/>
          <p:nvPr/>
        </p:nvSpPr>
        <p:spPr>
          <a:xfrm>
            <a:off x="7007011" y="1360794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E3B8C9B-ED66-4CD6-95EC-F9FDF8C06BAB}"/>
              </a:ext>
            </a:extLst>
          </p:cNvPr>
          <p:cNvSpPr txBox="1"/>
          <p:nvPr/>
        </p:nvSpPr>
        <p:spPr>
          <a:xfrm>
            <a:off x="6716933" y="1360794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B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FF0FB79-99BC-4E6C-9FEF-A9B2200249FA}"/>
              </a:ext>
            </a:extLst>
          </p:cNvPr>
          <p:cNvCxnSpPr>
            <a:cxnSpLocks/>
          </p:cNvCxnSpPr>
          <p:nvPr/>
        </p:nvCxnSpPr>
        <p:spPr>
          <a:xfrm flipH="1">
            <a:off x="7481807" y="2112159"/>
            <a:ext cx="663903" cy="3542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35B5455E-675C-4475-BE01-536BFDF6CD6C}"/>
              </a:ext>
            </a:extLst>
          </p:cNvPr>
          <p:cNvSpPr txBox="1"/>
          <p:nvPr/>
        </p:nvSpPr>
        <p:spPr>
          <a:xfrm>
            <a:off x="8036653" y="1811914"/>
            <a:ext cx="2680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and from an adjacent membran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B7A712-7FA5-4BCD-BF33-EEED32E4F920}"/>
              </a:ext>
            </a:extLst>
          </p:cNvPr>
          <p:cNvSpPr txBox="1"/>
          <p:nvPr/>
        </p:nvSpPr>
        <p:spPr>
          <a:xfrm>
            <a:off x="8036653" y="3402109"/>
            <a:ext cx="26803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and from an adjacent membrane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1E5F1C44-19C7-40D2-9DAC-8881A1E07414}"/>
              </a:ext>
            </a:extLst>
          </p:cNvPr>
          <p:cNvCxnSpPr>
            <a:cxnSpLocks/>
            <a:stCxn id="17" idx="1"/>
          </p:cNvCxnSpPr>
          <p:nvPr/>
        </p:nvCxnSpPr>
        <p:spPr>
          <a:xfrm flipH="1">
            <a:off x="7481807" y="3555998"/>
            <a:ext cx="554846" cy="1183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BB64957-FB1A-46CF-B8E5-F5B52EBB2BBB}"/>
              </a:ext>
            </a:extLst>
          </p:cNvPr>
          <p:cNvCxnSpPr>
            <a:cxnSpLocks/>
          </p:cNvCxnSpPr>
          <p:nvPr/>
        </p:nvCxnSpPr>
        <p:spPr>
          <a:xfrm flipH="1">
            <a:off x="4262208" y="3268244"/>
            <a:ext cx="554846" cy="876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881D808-6FCF-42D4-AAFA-4D3B1482DF1A}"/>
              </a:ext>
            </a:extLst>
          </p:cNvPr>
          <p:cNvCxnSpPr>
            <a:cxnSpLocks/>
          </p:cNvCxnSpPr>
          <p:nvPr/>
        </p:nvCxnSpPr>
        <p:spPr>
          <a:xfrm flipH="1">
            <a:off x="4193809" y="1724311"/>
            <a:ext cx="554846" cy="876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C5C280C4-F6BE-444D-B17F-E277B0DB1F8B}"/>
              </a:ext>
            </a:extLst>
          </p:cNvPr>
          <p:cNvSpPr txBox="1"/>
          <p:nvPr/>
        </p:nvSpPr>
        <p:spPr>
          <a:xfrm>
            <a:off x="4670122" y="1452849"/>
            <a:ext cx="9044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acent</a:t>
            </a:r>
          </a:p>
          <a:p>
            <a:r>
              <a:rPr lang="en-US" sz="1200" dirty="0"/>
              <a:t> membran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D8BDE30-CE83-484E-8546-3CBD4F6BB7FF}"/>
              </a:ext>
            </a:extLst>
          </p:cNvPr>
          <p:cNvSpPr txBox="1"/>
          <p:nvPr/>
        </p:nvSpPr>
        <p:spPr>
          <a:xfrm>
            <a:off x="4614330" y="3032777"/>
            <a:ext cx="9044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acent</a:t>
            </a:r>
          </a:p>
          <a:p>
            <a:r>
              <a:rPr lang="en-US" sz="1200" dirty="0"/>
              <a:t> membrane</a:t>
            </a:r>
          </a:p>
        </p:txBody>
      </p:sp>
    </p:spTree>
    <p:extLst>
      <p:ext uri="{BB962C8B-B14F-4D97-AF65-F5344CB8AC3E}">
        <p14:creationId xmlns:p14="http://schemas.microsoft.com/office/powerpoint/2010/main" val="6147375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4A1E4541-382A-4985-98ED-3F1783984C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4226715"/>
              </p:ext>
            </p:extLst>
          </p:nvPr>
        </p:nvGraphicFramePr>
        <p:xfrm>
          <a:off x="10300519" y="1092166"/>
          <a:ext cx="1380227" cy="56680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r:id="rId3" imgW="1866600" imgH="7675920" progId="">
                  <p:embed/>
                </p:oleObj>
              </mc:Choice>
              <mc:Fallback>
                <p:oleObj r:id="rId3" imgW="1866600" imgH="76759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300519" y="1092166"/>
                        <a:ext cx="1380227" cy="56680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EA5AB49-E9A6-4BB9-A156-093DC9858577}"/>
              </a:ext>
            </a:extLst>
          </p:cNvPr>
          <p:cNvSpPr txBox="1"/>
          <p:nvPr/>
        </p:nvSpPr>
        <p:spPr>
          <a:xfrm>
            <a:off x="10458388" y="510936"/>
            <a:ext cx="113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ta-actin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A14C831-DFC7-45D6-A10F-405581EAD5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674292"/>
              </p:ext>
            </p:extLst>
          </p:nvPr>
        </p:nvGraphicFramePr>
        <p:xfrm>
          <a:off x="5911822" y="1400501"/>
          <a:ext cx="1834122" cy="3720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r:id="rId5" imgW="2685600" imgH="5447520" progId="">
                  <p:embed/>
                </p:oleObj>
              </mc:Choice>
              <mc:Fallback>
                <p:oleObj r:id="rId5" imgW="2685600" imgH="5447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11822" y="1400501"/>
                        <a:ext cx="1834122" cy="3720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ECB139F6-B912-4A8F-9DBE-B144349066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6858740"/>
              </p:ext>
            </p:extLst>
          </p:nvPr>
        </p:nvGraphicFramePr>
        <p:xfrm>
          <a:off x="2032572" y="1547484"/>
          <a:ext cx="1918970" cy="38984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r:id="rId7" imgW="2971080" imgH="6037920" progId="">
                  <p:embed/>
                </p:oleObj>
              </mc:Choice>
              <mc:Fallback>
                <p:oleObj r:id="rId7" imgW="2971080" imgH="60379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32572" y="1547484"/>
                        <a:ext cx="1918970" cy="38984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797CBA8C-7144-4B96-81DF-A2BD2046BC54}"/>
              </a:ext>
            </a:extLst>
          </p:cNvPr>
          <p:cNvSpPr txBox="1"/>
          <p:nvPr/>
        </p:nvSpPr>
        <p:spPr>
          <a:xfrm>
            <a:off x="2681699" y="1074714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K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6EB7B17-4D75-491E-B6AD-1BAC2AB959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9023065"/>
              </p:ext>
            </p:extLst>
          </p:nvPr>
        </p:nvGraphicFramePr>
        <p:xfrm>
          <a:off x="3981385" y="1826345"/>
          <a:ext cx="1963843" cy="3294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2" r:id="rId9" imgW="4933080" imgH="8285400" progId="">
                  <p:embed/>
                </p:oleObj>
              </mc:Choice>
              <mc:Fallback>
                <p:oleObj r:id="rId9" imgW="493308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81385" y="1826345"/>
                        <a:ext cx="1963843" cy="3294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A3186E57-89EB-4D4A-AEBD-D900519FEB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4734786"/>
              </p:ext>
            </p:extLst>
          </p:nvPr>
        </p:nvGraphicFramePr>
        <p:xfrm>
          <a:off x="170166" y="1794395"/>
          <a:ext cx="1932208" cy="33440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3" r:id="rId11" imgW="4780800" imgH="8285400" progId="">
                  <p:embed/>
                </p:oleObj>
              </mc:Choice>
              <mc:Fallback>
                <p:oleObj r:id="rId11" imgW="478080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70166" y="1794395"/>
                        <a:ext cx="1932208" cy="33440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EA05943A-5B70-49A8-98B2-D843CE780187}"/>
              </a:ext>
            </a:extLst>
          </p:cNvPr>
          <p:cNvSpPr txBox="1"/>
          <p:nvPr/>
        </p:nvSpPr>
        <p:spPr>
          <a:xfrm>
            <a:off x="2544498" y="151413"/>
            <a:ext cx="6957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 vitro treated mammary cancer cells-Western blot-G Box imager scans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3D91D4D-01CA-49BA-BB6F-2181D7BFA9F0}"/>
              </a:ext>
            </a:extLst>
          </p:cNvPr>
          <p:cNvSpPr txBox="1"/>
          <p:nvPr/>
        </p:nvSpPr>
        <p:spPr>
          <a:xfrm>
            <a:off x="181601" y="1499341"/>
            <a:ext cx="1549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hite light pictu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89513ED-8520-4A41-B074-C105C962A1C2}"/>
              </a:ext>
            </a:extLst>
          </p:cNvPr>
          <p:cNvSpPr txBox="1"/>
          <p:nvPr/>
        </p:nvSpPr>
        <p:spPr>
          <a:xfrm>
            <a:off x="2244192" y="1362818"/>
            <a:ext cx="15439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0" i="0" dirty="0">
                <a:effectLst/>
              </a:rPr>
              <a:t>Chemiluminescent</a:t>
            </a:r>
          </a:p>
          <a:p>
            <a:pPr algn="ctr"/>
            <a:r>
              <a:rPr lang="en-US" sz="1400" b="0" i="0" dirty="0">
                <a:effectLst/>
              </a:rPr>
              <a:t> detection</a:t>
            </a:r>
            <a:r>
              <a:rPr lang="en-US" sz="1400" dirty="0"/>
              <a:t>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2C4E47-21BE-4923-A650-47A542EC9599}"/>
              </a:ext>
            </a:extLst>
          </p:cNvPr>
          <p:cNvSpPr txBox="1"/>
          <p:nvPr/>
        </p:nvSpPr>
        <p:spPr>
          <a:xfrm>
            <a:off x="2404075" y="1807118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4490E60-4550-4678-B3F9-5E83C3193250}"/>
              </a:ext>
            </a:extLst>
          </p:cNvPr>
          <p:cNvSpPr txBox="1"/>
          <p:nvPr/>
        </p:nvSpPr>
        <p:spPr>
          <a:xfrm>
            <a:off x="3324456" y="1807118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8CD4852-F2E5-4206-96B6-71ECD2705CFD}"/>
              </a:ext>
            </a:extLst>
          </p:cNvPr>
          <p:cNvSpPr txBox="1"/>
          <p:nvPr/>
        </p:nvSpPr>
        <p:spPr>
          <a:xfrm>
            <a:off x="2848067" y="1807118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66A5E9-B770-4958-9AA0-217BA9B2C5E5}"/>
              </a:ext>
            </a:extLst>
          </p:cNvPr>
          <p:cNvSpPr txBox="1"/>
          <p:nvPr/>
        </p:nvSpPr>
        <p:spPr>
          <a:xfrm>
            <a:off x="6283604" y="182634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DB6D3C2-7F41-48D6-A706-896863213FAF}"/>
              </a:ext>
            </a:extLst>
          </p:cNvPr>
          <p:cNvSpPr txBox="1"/>
          <p:nvPr/>
        </p:nvSpPr>
        <p:spPr>
          <a:xfrm>
            <a:off x="7203985" y="1826345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8A57672-508F-4E6B-8597-DA65B9530D81}"/>
              </a:ext>
            </a:extLst>
          </p:cNvPr>
          <p:cNvSpPr txBox="1"/>
          <p:nvPr/>
        </p:nvSpPr>
        <p:spPr>
          <a:xfrm>
            <a:off x="6727596" y="1826345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6AC037-373A-4FFC-BEBB-FA2133030AF5}"/>
              </a:ext>
            </a:extLst>
          </p:cNvPr>
          <p:cNvSpPr txBox="1"/>
          <p:nvPr/>
        </p:nvSpPr>
        <p:spPr>
          <a:xfrm>
            <a:off x="6619661" y="1074714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MEK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AC9562-D9C8-4233-8DFC-A34E5FEAB20C}"/>
              </a:ext>
            </a:extLst>
          </p:cNvPr>
          <p:cNvSpPr txBox="1"/>
          <p:nvPr/>
        </p:nvSpPr>
        <p:spPr>
          <a:xfrm>
            <a:off x="4139434" y="1500938"/>
            <a:ext cx="1549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hite light pictur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68C3E23-35B4-460F-BA80-02DAD510E50A}"/>
              </a:ext>
            </a:extLst>
          </p:cNvPr>
          <p:cNvSpPr txBox="1"/>
          <p:nvPr/>
        </p:nvSpPr>
        <p:spPr>
          <a:xfrm>
            <a:off x="6180813" y="1329531"/>
            <a:ext cx="15439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0" i="0" dirty="0">
                <a:effectLst/>
              </a:rPr>
              <a:t>Chemiluminescent</a:t>
            </a:r>
          </a:p>
          <a:p>
            <a:pPr algn="ctr"/>
            <a:r>
              <a:rPr lang="en-US" sz="1400" b="0" i="0" dirty="0">
                <a:effectLst/>
              </a:rPr>
              <a:t> detection</a:t>
            </a:r>
            <a:r>
              <a:rPr lang="en-US" sz="1400" dirty="0"/>
              <a:t> </a:t>
            </a:r>
          </a:p>
        </p:txBody>
      </p:sp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5AA6F627-DE20-4D81-A32E-577018BCE8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7842258"/>
              </p:ext>
            </p:extLst>
          </p:nvPr>
        </p:nvGraphicFramePr>
        <p:xfrm>
          <a:off x="8520983" y="1202061"/>
          <a:ext cx="1479550" cy="554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4" r:id="rId13" imgW="2209320" imgH="8285400" progId="">
                  <p:embed/>
                </p:oleObj>
              </mc:Choice>
              <mc:Fallback>
                <p:oleObj r:id="rId13" imgW="220932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520983" y="1202061"/>
                        <a:ext cx="1479550" cy="554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52A96BBA-CB65-4317-BCCB-FD6DEEB07BC8}"/>
              </a:ext>
            </a:extLst>
          </p:cNvPr>
          <p:cNvSpPr txBox="1"/>
          <p:nvPr/>
        </p:nvSpPr>
        <p:spPr>
          <a:xfrm>
            <a:off x="8451304" y="544700"/>
            <a:ext cx="147954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erged white light and </a:t>
            </a:r>
            <a:r>
              <a:rPr lang="en-US" sz="1400" dirty="0" err="1"/>
              <a:t>chemilum</a:t>
            </a:r>
            <a:r>
              <a:rPr lang="en-US" sz="1400" dirty="0"/>
              <a:t>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249C876-D38E-4912-8355-7F096F56088D}"/>
              </a:ext>
            </a:extLst>
          </p:cNvPr>
          <p:cNvSpPr txBox="1"/>
          <p:nvPr/>
        </p:nvSpPr>
        <p:spPr>
          <a:xfrm>
            <a:off x="10295395" y="843833"/>
            <a:ext cx="15631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0" i="0" dirty="0">
                <a:effectLst/>
              </a:rPr>
              <a:t>chemiluminescent </a:t>
            </a:r>
          </a:p>
          <a:p>
            <a:pPr algn="ctr"/>
            <a:r>
              <a:rPr lang="en-US" sz="1400" b="0" i="0" dirty="0">
                <a:effectLst/>
              </a:rPr>
              <a:t>detection</a:t>
            </a:r>
            <a:r>
              <a:rPr lang="en-US" sz="1400" dirty="0"/>
              <a:t>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05435F6-063A-4999-875E-7FA934FEB393}"/>
              </a:ext>
            </a:extLst>
          </p:cNvPr>
          <p:cNvSpPr txBox="1"/>
          <p:nvPr/>
        </p:nvSpPr>
        <p:spPr>
          <a:xfrm>
            <a:off x="10630264" y="127117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58B69AA-5EEC-4DDC-AF48-112125CD4229}"/>
              </a:ext>
            </a:extLst>
          </p:cNvPr>
          <p:cNvSpPr txBox="1"/>
          <p:nvPr/>
        </p:nvSpPr>
        <p:spPr>
          <a:xfrm>
            <a:off x="11250396" y="1283364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5EA7C8C-A9A3-4644-AD2F-2C59FDCDD262}"/>
              </a:ext>
            </a:extLst>
          </p:cNvPr>
          <p:cNvSpPr txBox="1"/>
          <p:nvPr/>
        </p:nvSpPr>
        <p:spPr>
          <a:xfrm>
            <a:off x="10923099" y="1271174"/>
            <a:ext cx="30777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054052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A1B89EAB-FEAF-41AF-92BC-67F12BB064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3963333"/>
              </p:ext>
            </p:extLst>
          </p:nvPr>
        </p:nvGraphicFramePr>
        <p:xfrm>
          <a:off x="4222212" y="1828800"/>
          <a:ext cx="1517605" cy="44212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r:id="rId3" imgW="2837880" imgH="8285400" progId="">
                  <p:embed/>
                </p:oleObj>
              </mc:Choice>
              <mc:Fallback>
                <p:oleObj r:id="rId3" imgW="283788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22212" y="1828800"/>
                        <a:ext cx="1517605" cy="44212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DAD6E01-975A-4CF3-81CB-B61DC4AB2E02}"/>
              </a:ext>
            </a:extLst>
          </p:cNvPr>
          <p:cNvSpPr txBox="1"/>
          <p:nvPr/>
        </p:nvSpPr>
        <p:spPr>
          <a:xfrm>
            <a:off x="5788221" y="2265028"/>
            <a:ext cx="663964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K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 err="1"/>
              <a:t>pERK</a:t>
            </a:r>
            <a:endParaRPr lang="en-US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6BD822F-65F2-4C84-BF7A-6F51715E2B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2986572"/>
              </p:ext>
            </p:extLst>
          </p:nvPr>
        </p:nvGraphicFramePr>
        <p:xfrm>
          <a:off x="2106406" y="1828800"/>
          <a:ext cx="1835755" cy="4558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r:id="rId5" imgW="3333240" imgH="8285400" progId="">
                  <p:embed/>
                </p:oleObj>
              </mc:Choice>
              <mc:Fallback>
                <p:oleObj r:id="rId5" imgW="333324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06406" y="1828800"/>
                        <a:ext cx="1835755" cy="45580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4B0FD0B-5ADD-4185-9762-2E145B405ACF}"/>
              </a:ext>
            </a:extLst>
          </p:cNvPr>
          <p:cNvSpPr txBox="1"/>
          <p:nvPr/>
        </p:nvSpPr>
        <p:spPr>
          <a:xfrm>
            <a:off x="2544498" y="151413"/>
            <a:ext cx="6957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 vitro treated mammary cancer cells-Western blot-G Box imager scans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E4D6D6-B068-4E6C-9429-A57BC65A33F6}"/>
              </a:ext>
            </a:extLst>
          </p:cNvPr>
          <p:cNvSpPr txBox="1"/>
          <p:nvPr/>
        </p:nvSpPr>
        <p:spPr>
          <a:xfrm>
            <a:off x="2201506" y="843833"/>
            <a:ext cx="147954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erged white light and </a:t>
            </a:r>
            <a:r>
              <a:rPr lang="en-US" sz="1400" dirty="0" err="1"/>
              <a:t>chemilum</a:t>
            </a:r>
            <a:r>
              <a:rPr lang="en-US" sz="1400" dirty="0"/>
              <a:t>. (higher exposure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429DD25-C1EA-45AF-841F-0064E31473CB}"/>
              </a:ext>
            </a:extLst>
          </p:cNvPr>
          <p:cNvSpPr txBox="1"/>
          <p:nvPr/>
        </p:nvSpPr>
        <p:spPr>
          <a:xfrm>
            <a:off x="4225036" y="1262876"/>
            <a:ext cx="15631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0" i="0" dirty="0">
                <a:effectLst/>
              </a:rPr>
              <a:t>chemiluminescent </a:t>
            </a:r>
          </a:p>
          <a:p>
            <a:pPr algn="ctr"/>
            <a:r>
              <a:rPr lang="en-US" sz="1400" b="0" i="0" dirty="0">
                <a:effectLst/>
              </a:rPr>
              <a:t>detection</a:t>
            </a:r>
            <a:r>
              <a:rPr lang="en-US" sz="1400" dirty="0"/>
              <a:t>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8BE1093-1507-48D9-857D-0BD0CEDA4F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9653613"/>
              </p:ext>
            </p:extLst>
          </p:nvPr>
        </p:nvGraphicFramePr>
        <p:xfrm>
          <a:off x="6780460" y="1332897"/>
          <a:ext cx="2120900" cy="554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7" r:id="rId7" imgW="3161880" imgH="8285400" progId="">
                  <p:embed/>
                </p:oleObj>
              </mc:Choice>
              <mc:Fallback>
                <p:oleObj r:id="rId7" imgW="3161880" imgH="8285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780460" y="1332897"/>
                        <a:ext cx="2120900" cy="554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2E3FD5C-BCB8-4AA4-B11E-7451AD3533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2561609"/>
              </p:ext>
            </p:extLst>
          </p:nvPr>
        </p:nvGraphicFramePr>
        <p:xfrm>
          <a:off x="9290484" y="1320886"/>
          <a:ext cx="1981200" cy="5162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8" r:id="rId9" imgW="2952360" imgH="7714080" progId="">
                  <p:embed/>
                </p:oleObj>
              </mc:Choice>
              <mc:Fallback>
                <p:oleObj r:id="rId9" imgW="2952360" imgH="7714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290484" y="1320886"/>
                        <a:ext cx="1981200" cy="5162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9DC6B08E-DB8B-4B00-843F-43670140B9D0}"/>
              </a:ext>
            </a:extLst>
          </p:cNvPr>
          <p:cNvSpPr txBox="1"/>
          <p:nvPr/>
        </p:nvSpPr>
        <p:spPr>
          <a:xfrm>
            <a:off x="7174948" y="607486"/>
            <a:ext cx="147954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Merged white light and </a:t>
            </a:r>
            <a:r>
              <a:rPr lang="en-US" sz="1400" dirty="0" err="1"/>
              <a:t>chemilum</a:t>
            </a:r>
            <a:r>
              <a:rPr lang="en-US" sz="1400" dirty="0"/>
              <a:t>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96FE23E-965F-4919-8536-E5F14D3813BE}"/>
              </a:ext>
            </a:extLst>
          </p:cNvPr>
          <p:cNvSpPr txBox="1"/>
          <p:nvPr/>
        </p:nvSpPr>
        <p:spPr>
          <a:xfrm>
            <a:off x="9694905" y="948196"/>
            <a:ext cx="15631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0" i="0" dirty="0">
                <a:effectLst/>
              </a:rPr>
              <a:t>chemiluminescent </a:t>
            </a:r>
          </a:p>
          <a:p>
            <a:pPr algn="ctr"/>
            <a:r>
              <a:rPr lang="en-US" sz="1400" b="0" i="0" dirty="0">
                <a:effectLst/>
              </a:rPr>
              <a:t>detection</a:t>
            </a:r>
            <a:r>
              <a:rPr lang="en-US" sz="1400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DE0785-A3B9-4B1A-9963-0573483A7DAA}"/>
              </a:ext>
            </a:extLst>
          </p:cNvPr>
          <p:cNvSpPr txBox="1"/>
          <p:nvPr/>
        </p:nvSpPr>
        <p:spPr>
          <a:xfrm>
            <a:off x="9815120" y="659167"/>
            <a:ext cx="113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ta-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EB3477A-7FCB-477C-A6DF-A8F08988993B}"/>
              </a:ext>
            </a:extLst>
          </p:cNvPr>
          <p:cNvSpPr txBox="1"/>
          <p:nvPr/>
        </p:nvSpPr>
        <p:spPr>
          <a:xfrm>
            <a:off x="11181440" y="4498394"/>
            <a:ext cx="10322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ta-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61414A-0061-4D95-B4E3-98589E430C2A}"/>
              </a:ext>
            </a:extLst>
          </p:cNvPr>
          <p:cNvSpPr txBox="1"/>
          <p:nvPr/>
        </p:nvSpPr>
        <p:spPr>
          <a:xfrm>
            <a:off x="11181440" y="1851776"/>
            <a:ext cx="10322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eta-actin</a:t>
            </a:r>
          </a:p>
        </p:txBody>
      </p:sp>
    </p:spTree>
    <p:extLst>
      <p:ext uri="{BB962C8B-B14F-4D97-AF65-F5344CB8AC3E}">
        <p14:creationId xmlns:p14="http://schemas.microsoft.com/office/powerpoint/2010/main" val="2193828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195</Words>
  <Application>Microsoft Office PowerPoint</Application>
  <PresentationFormat>Widescreen</PresentationFormat>
  <Paragraphs>81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bova, Ludmila (NIH/NCI) [C]</dc:creator>
  <cp:lastModifiedBy>Szabova, Ludmila (NIH/NCI) [C]</cp:lastModifiedBy>
  <cp:revision>11</cp:revision>
  <dcterms:created xsi:type="dcterms:W3CDTF">2022-06-10T12:16:17Z</dcterms:created>
  <dcterms:modified xsi:type="dcterms:W3CDTF">2022-06-10T14:52:52Z</dcterms:modified>
</cp:coreProperties>
</file>